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00"/>
    <a:srgbClr val="38D71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9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346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283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2526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93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705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86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941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799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970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362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977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BFC988-35A7-40D2-A6B1-60FD7A5D46E4}" type="datetimeFigureOut">
              <a:rPr lang="en-US" smtClean="0"/>
              <a:t>10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C0AA72-65C1-409C-8BBF-2E9410F72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98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0624" y="1384429"/>
            <a:ext cx="2400300" cy="2381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0624" y="1995172"/>
            <a:ext cx="2400300" cy="3333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11659" y="1332525"/>
            <a:ext cx="18389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ischemic  BE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824695" y="1977192"/>
            <a:ext cx="1428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chemic BEC </a:t>
            </a:r>
          </a:p>
        </p:txBody>
      </p:sp>
      <p:sp>
        <p:nvSpPr>
          <p:cNvPr id="8" name="Lightning Bolt 7"/>
          <p:cNvSpPr/>
          <p:nvPr/>
        </p:nvSpPr>
        <p:spPr>
          <a:xfrm flipH="1">
            <a:off x="4589230" y="781654"/>
            <a:ext cx="356616" cy="528565"/>
          </a:xfrm>
          <a:prstGeom prst="lightningBol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653609" y="227699"/>
            <a:ext cx="242406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ute Experimental Stroke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CAO model in rats)</a:t>
            </a:r>
          </a:p>
        </p:txBody>
      </p:sp>
      <p:cxnSp>
        <p:nvCxnSpPr>
          <p:cNvPr id="12" name="Straight Arrow Connector 11"/>
          <p:cNvCxnSpPr>
            <a:stCxn id="4" idx="2"/>
            <a:endCxn id="5" idx="0"/>
          </p:cNvCxnSpPr>
          <p:nvPr/>
        </p:nvCxnSpPr>
        <p:spPr>
          <a:xfrm>
            <a:off x="4750774" y="1622553"/>
            <a:ext cx="0" cy="37261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6022171" y="1808862"/>
            <a:ext cx="241493" cy="25191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ounded Rectangle 14"/>
          <p:cNvSpPr/>
          <p:nvPr/>
        </p:nvSpPr>
        <p:spPr>
          <a:xfrm>
            <a:off x="4193522" y="2701164"/>
            <a:ext cx="1114505" cy="566968"/>
          </a:xfrm>
          <a:prstGeom prst="round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rgbClr val="006600"/>
                </a:solidFill>
              </a:rPr>
              <a:t>J147</a:t>
            </a:r>
          </a:p>
        </p:txBody>
      </p:sp>
      <p:cxnSp>
        <p:nvCxnSpPr>
          <p:cNvPr id="17" name="Curved Connector 16"/>
          <p:cNvCxnSpPr/>
          <p:nvPr/>
        </p:nvCxnSpPr>
        <p:spPr>
          <a:xfrm rot="5400000">
            <a:off x="3196553" y="2354711"/>
            <a:ext cx="1365120" cy="1348750"/>
          </a:xfrm>
          <a:prstGeom prst="curvedConnector3">
            <a:avLst>
              <a:gd name="adj1" fmla="val 18319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urved Connector 24"/>
          <p:cNvCxnSpPr/>
          <p:nvPr/>
        </p:nvCxnSpPr>
        <p:spPr>
          <a:xfrm rot="16200000" flipH="1">
            <a:off x="4982773" y="2288195"/>
            <a:ext cx="1280160" cy="1371600"/>
          </a:xfrm>
          <a:prstGeom prst="curvedConnector3">
            <a:avLst>
              <a:gd name="adj1" fmla="val 18319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1919747" y="3703756"/>
            <a:ext cx="18068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P9, 15-LOX-1, PAI-1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491315" y="3533538"/>
            <a:ext cx="2560320" cy="6401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216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telet activation</a:t>
            </a:r>
          </a:p>
          <a:p>
            <a:pPr algn="ctr">
              <a:lnSpc>
                <a:spcPts val="216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rin &amp; platelet deposition</a:t>
            </a:r>
          </a:p>
        </p:txBody>
      </p:sp>
      <p:cxnSp>
        <p:nvCxnSpPr>
          <p:cNvPr id="33" name="Curved Connector 32"/>
          <p:cNvCxnSpPr>
            <a:cxnSpLocks/>
          </p:cNvCxnSpPr>
          <p:nvPr/>
        </p:nvCxnSpPr>
        <p:spPr>
          <a:xfrm>
            <a:off x="3409260" y="4771800"/>
            <a:ext cx="488698" cy="430762"/>
          </a:xfrm>
          <a:prstGeom prst="curvedConnector3">
            <a:avLst>
              <a:gd name="adj1" fmla="val 50000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1781994" y="4472961"/>
            <a:ext cx="2926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morrhagic transformation</a:t>
            </a:r>
          </a:p>
        </p:txBody>
      </p:sp>
      <p:cxnSp>
        <p:nvCxnSpPr>
          <p:cNvPr id="46" name="Straight Arrow Connector 45"/>
          <p:cNvCxnSpPr/>
          <p:nvPr/>
        </p:nvCxnSpPr>
        <p:spPr>
          <a:xfrm>
            <a:off x="2976939" y="4222280"/>
            <a:ext cx="0" cy="27432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5219866" y="3363246"/>
            <a:ext cx="521905" cy="35161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flipH="1">
            <a:off x="3798245" y="3360436"/>
            <a:ext cx="521905" cy="35161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3726643" y="3611724"/>
            <a:ext cx="152471" cy="1864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>
            <a:off x="5660902" y="3637920"/>
            <a:ext cx="152471" cy="18647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urved Connector 60"/>
          <p:cNvCxnSpPr>
            <a:cxnSpLocks/>
          </p:cNvCxnSpPr>
          <p:nvPr/>
        </p:nvCxnSpPr>
        <p:spPr>
          <a:xfrm rot="10800000" flipV="1">
            <a:off x="6042122" y="4895470"/>
            <a:ext cx="502920" cy="360479"/>
          </a:xfrm>
          <a:prstGeom prst="curvedConnector3">
            <a:avLst>
              <a:gd name="adj1" fmla="val 50000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Arrow Connector 2"/>
          <p:cNvCxnSpPr/>
          <p:nvPr/>
        </p:nvCxnSpPr>
        <p:spPr>
          <a:xfrm flipV="1">
            <a:off x="3718658" y="3888016"/>
            <a:ext cx="1858023" cy="17168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6142917" y="1453276"/>
            <a:ext cx="786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V </a:t>
            </a:r>
            <a:r>
              <a:rPr lang="en-US" sz="1600" b="1" dirty="0" err="1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PA</a:t>
            </a:r>
            <a:endParaRPr lang="en-US" sz="160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35164" y="4136328"/>
            <a:ext cx="231668" cy="390178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3127048" y="5262695"/>
            <a:ext cx="363759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rological deterioration after delayed thrombolysi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CED38FB-47D3-4B89-BF4B-6F4F947FFDE3}"/>
              </a:ext>
            </a:extLst>
          </p:cNvPr>
          <p:cNvSpPr txBox="1"/>
          <p:nvPr/>
        </p:nvSpPr>
        <p:spPr>
          <a:xfrm>
            <a:off x="5281126" y="4348985"/>
            <a:ext cx="26517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stream microvascular thrombosis</a:t>
            </a:r>
          </a:p>
        </p:txBody>
      </p:sp>
    </p:spTree>
    <p:extLst>
      <p:ext uri="{BB962C8B-B14F-4D97-AF65-F5344CB8AC3E}">
        <p14:creationId xmlns:p14="http://schemas.microsoft.com/office/powerpoint/2010/main" val="1505607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8512F6B-3BBC-4908-8AD9-199D0FC7D307}"/>
              </a:ext>
            </a:extLst>
          </p:cNvPr>
          <p:cNvSpPr txBox="1"/>
          <p:nvPr/>
        </p:nvSpPr>
        <p:spPr>
          <a:xfrm>
            <a:off x="1618861" y="1270939"/>
            <a:ext cx="5906278" cy="3293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ual Abstract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We demonstrated for the first time that J147, a novel well‐documented neurotrophic compound, may block delayed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P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induced brain hemorrhage and confers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rebroprotectiv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ffects in acute experimental stroke.  Mechanistically, we found two important beneficial actions of J147.  First, J147 may reduce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P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‐associated hemorrhagic transformation by suppressing MMP‐9 and 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5-LOX-1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ischemic brain endothelial cells (BEC).  Second, </a:t>
            </a:r>
            <a:r>
              <a:rPr lang="en-US" sz="1600" kern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cond, J147 may attenuate stroke-induced circulating platelet activation and cerebral endothelial PAI-1 expression, leading to reduced downstream microvascular thrombosis and improved effectiveness of thrombolytic therapy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ur data suggest that combining J147 with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P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y be a clinically feasible way toward future attempts at combination stroke therapy.</a:t>
            </a:r>
          </a:p>
        </p:txBody>
      </p:sp>
    </p:spTree>
    <p:extLst>
      <p:ext uri="{BB962C8B-B14F-4D97-AF65-F5344CB8AC3E}">
        <p14:creationId xmlns:p14="http://schemas.microsoft.com/office/powerpoint/2010/main" val="33426451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</TotalTime>
  <Words>160</Words>
  <Application>Microsoft Office PowerPoint</Application>
  <PresentationFormat>On-screen Show (4:3)</PresentationFormat>
  <Paragraphs>1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Penn State Hershe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g Jin</dc:creator>
  <cp:lastModifiedBy>James Li</cp:lastModifiedBy>
  <cp:revision>25</cp:revision>
  <cp:lastPrinted>2021-09-27T16:01:02Z</cp:lastPrinted>
  <dcterms:created xsi:type="dcterms:W3CDTF">2017-12-18T20:10:30Z</dcterms:created>
  <dcterms:modified xsi:type="dcterms:W3CDTF">2021-10-09T03:14:28Z</dcterms:modified>
</cp:coreProperties>
</file>